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7" d="100"/>
          <a:sy n="87" d="100"/>
        </p:scale>
        <p:origin x="-2080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DA59C1-6DE3-3842-9574-FA5B4609B35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EFE14-3742-714F-A15A-AD41960498B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29336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DA59C1-6DE3-3842-9574-FA5B4609B35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EFE14-3742-714F-A15A-AD41960498B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338371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DA59C1-6DE3-3842-9574-FA5B4609B35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EFE14-3742-714F-A15A-AD41960498B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423241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DA59C1-6DE3-3842-9574-FA5B4609B35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EFE14-3742-714F-A15A-AD41960498B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95839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DA59C1-6DE3-3842-9574-FA5B4609B35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EFE14-3742-714F-A15A-AD41960498B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481440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DA59C1-6DE3-3842-9574-FA5B4609B35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EFE14-3742-714F-A15A-AD41960498B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49622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DA59C1-6DE3-3842-9574-FA5B4609B35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EFE14-3742-714F-A15A-AD41960498B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70284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DA59C1-6DE3-3842-9574-FA5B4609B35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EFE14-3742-714F-A15A-AD41960498B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591491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DA59C1-6DE3-3842-9574-FA5B4609B35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EFE14-3742-714F-A15A-AD41960498B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51855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DA59C1-6DE3-3842-9574-FA5B4609B35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EFE14-3742-714F-A15A-AD41960498B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176234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DA59C1-6DE3-3842-9574-FA5B4609B35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EFE14-3742-714F-A15A-AD41960498B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791067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DA59C1-6DE3-3842-9574-FA5B4609B355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1EFE14-3742-714F-A15A-AD41960498B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77932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2920066"/>
              </p:ext>
            </p:extLst>
          </p:nvPr>
        </p:nvGraphicFramePr>
        <p:xfrm>
          <a:off x="1333500" y="2059622"/>
          <a:ext cx="6146800" cy="1714500"/>
        </p:xfrm>
        <a:graphic>
          <a:graphicData uri="http://schemas.openxmlformats.org/drawingml/2006/table">
            <a:tbl>
              <a:tblPr/>
              <a:tblGrid>
                <a:gridCol w="685800"/>
                <a:gridCol w="609600"/>
                <a:gridCol w="876300"/>
                <a:gridCol w="723900"/>
                <a:gridCol w="1079500"/>
                <a:gridCol w="673100"/>
                <a:gridCol w="762000"/>
                <a:gridCol w="736600"/>
              </a:tblGrid>
              <a:tr h="190500">
                <a:tc gridSpan="8"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tient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x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urrent ag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nset ag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ower back pain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</a:t>
                      </a:r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B2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acroiliiti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adiology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S9_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e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ositiv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e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e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S9_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e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ositiv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e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e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S9_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D</a:t>
                      </a:r>
                      <a:endParaRPr lang="is-I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e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es</a:t>
                      </a:r>
                      <a:endParaRPr lang="ru-RU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D</a:t>
                      </a:r>
                      <a:endParaRPr lang="ru-RU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S9_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e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ositiv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es</a:t>
                      </a:r>
                      <a:endParaRPr lang="ru-RU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D</a:t>
                      </a:r>
                      <a:endParaRPr lang="ru-RU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S9_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e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ositive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e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e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AS_P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1</a:t>
                      </a:r>
                      <a:endParaRPr lang="ru-RU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</a:t>
                      </a:r>
                      <a:endParaRPr lang="ru-RU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es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ositive</a:t>
                      </a:r>
                      <a:endParaRPr lang="ru-RU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es</a:t>
                      </a:r>
                      <a:endParaRPr lang="ru-RU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es</a:t>
                      </a:r>
                      <a:endParaRPr lang="ru-RU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7602733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2</Words>
  <Application>Microsoft Macintosh PowerPoint</Application>
  <PresentationFormat>全屏显示(4:3)</PresentationFormat>
  <Paragraphs>56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Company>中南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ong Ma</dc:creator>
  <cp:lastModifiedBy>Long Ma</cp:lastModifiedBy>
  <cp:revision>1</cp:revision>
  <dcterms:created xsi:type="dcterms:W3CDTF">2018-06-04T06:23:42Z</dcterms:created>
  <dcterms:modified xsi:type="dcterms:W3CDTF">2018-06-04T06:24:04Z</dcterms:modified>
</cp:coreProperties>
</file>